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1589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ABE6B-B768-4F96-9F9F-383FF2AC587F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0018D-C7ED-4292-BAD7-840CE541435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ABE6B-B768-4F96-9F9F-383FF2AC587F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0018D-C7ED-4292-BAD7-840CE541435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ABE6B-B768-4F96-9F9F-383FF2AC587F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0018D-C7ED-4292-BAD7-840CE541435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ABE6B-B768-4F96-9F9F-383FF2AC587F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0018D-C7ED-4292-BAD7-840CE541435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ABE6B-B768-4F96-9F9F-383FF2AC587F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0018D-C7ED-4292-BAD7-840CE541435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ABE6B-B768-4F96-9F9F-383FF2AC587F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0018D-C7ED-4292-BAD7-840CE541435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ABE6B-B768-4F96-9F9F-383FF2AC587F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0018D-C7ED-4292-BAD7-840CE541435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ABE6B-B768-4F96-9F9F-383FF2AC587F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0018D-C7ED-4292-BAD7-840CE541435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ABE6B-B768-4F96-9F9F-383FF2AC587F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0018D-C7ED-4292-BAD7-840CE541435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ABE6B-B768-4F96-9F9F-383FF2AC587F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0018D-C7ED-4292-BAD7-840CE541435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ABE6B-B768-4F96-9F9F-383FF2AC587F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30018D-C7ED-4292-BAD7-840CE541435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7ABE6B-B768-4F96-9F9F-383FF2AC587F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30018D-C7ED-4292-BAD7-840CE5414358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32"/>
          <p:cNvGrpSpPr/>
          <p:nvPr/>
        </p:nvGrpSpPr>
        <p:grpSpPr>
          <a:xfrm>
            <a:off x="1219200" y="685800"/>
            <a:ext cx="6934200" cy="4953000"/>
            <a:chOff x="1219200" y="685800"/>
            <a:chExt cx="6934200" cy="4953000"/>
          </a:xfrm>
        </p:grpSpPr>
        <p:pic>
          <p:nvPicPr>
            <p:cNvPr id="2" name="Picture 1" descr="Intact HLA class I antigen 3D.png"/>
            <p:cNvPicPr>
              <a:picLocks noChangeAspect="1"/>
            </p:cNvPicPr>
            <p:nvPr/>
          </p:nvPicPr>
          <p:blipFill>
            <a:blip r:embed="rId2" cstate="print"/>
            <a:srcRect l="33333" t="25309" r="37500" b="3911"/>
            <a:stretch>
              <a:fillRect/>
            </a:stretch>
          </p:blipFill>
          <p:spPr>
            <a:xfrm>
              <a:off x="1600200" y="1524000"/>
              <a:ext cx="2021958" cy="2484120"/>
            </a:xfrm>
            <a:prstGeom prst="rect">
              <a:avLst/>
            </a:prstGeom>
          </p:spPr>
        </p:pic>
        <p:pic>
          <p:nvPicPr>
            <p:cNvPr id="3" name="Picture 2" descr="Dissociated HLA class I heavy chain only 3D.png"/>
            <p:cNvPicPr>
              <a:picLocks noChangeAspect="1"/>
            </p:cNvPicPr>
            <p:nvPr/>
          </p:nvPicPr>
          <p:blipFill>
            <a:blip r:embed="rId3" cstate="print"/>
            <a:srcRect l="33333" t="25309" r="37500" b="17079"/>
            <a:stretch>
              <a:fillRect/>
            </a:stretch>
          </p:blipFill>
          <p:spPr>
            <a:xfrm>
              <a:off x="5715000" y="1524000"/>
              <a:ext cx="2021958" cy="2021958"/>
            </a:xfrm>
            <a:prstGeom prst="rect">
              <a:avLst/>
            </a:prstGeom>
          </p:spPr>
        </p:pic>
        <p:pic>
          <p:nvPicPr>
            <p:cNvPr id="4" name="Picture 3" descr="Dissociated HLA class I B2m only 3D.png"/>
            <p:cNvPicPr>
              <a:picLocks noChangeAspect="1"/>
            </p:cNvPicPr>
            <p:nvPr/>
          </p:nvPicPr>
          <p:blipFill>
            <a:blip r:embed="rId4" cstate="print"/>
            <a:srcRect l="36667" t="45062" r="47500" b="5557"/>
            <a:stretch>
              <a:fillRect/>
            </a:stretch>
          </p:blipFill>
          <p:spPr>
            <a:xfrm>
              <a:off x="3352800" y="3276600"/>
              <a:ext cx="1097635" cy="1733107"/>
            </a:xfrm>
            <a:prstGeom prst="rect">
              <a:avLst/>
            </a:prstGeom>
          </p:spPr>
        </p:pic>
        <p:pic>
          <p:nvPicPr>
            <p:cNvPr id="5" name="Picture 4" descr="Dissociated HLA class I peptide only 3D.png"/>
            <p:cNvPicPr>
              <a:picLocks noChangeAspect="1"/>
            </p:cNvPicPr>
            <p:nvPr/>
          </p:nvPicPr>
          <p:blipFill>
            <a:blip r:embed="rId5" cstate="print"/>
            <a:srcRect l="41667" t="31893" r="45833" b="45062"/>
            <a:stretch>
              <a:fillRect/>
            </a:stretch>
          </p:blipFill>
          <p:spPr>
            <a:xfrm>
              <a:off x="4419600" y="3581400"/>
              <a:ext cx="866553" cy="808783"/>
            </a:xfrm>
            <a:prstGeom prst="rect">
              <a:avLst/>
            </a:prstGeom>
          </p:spPr>
        </p:pic>
        <p:sp>
          <p:nvSpPr>
            <p:cNvPr id="6" name="Rectangle 5"/>
            <p:cNvSpPr/>
            <p:nvPr/>
          </p:nvSpPr>
          <p:spPr>
            <a:xfrm>
              <a:off x="1219200" y="685800"/>
              <a:ext cx="6934200" cy="4953000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295400" y="914400"/>
              <a:ext cx="2788007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dirty="0" smtClean="0">
                  <a:latin typeface="Arial" pitchFamily="34" charset="0"/>
                  <a:cs typeface="Arial" pitchFamily="34" charset="0"/>
                </a:rPr>
                <a:t>Intact HLA class I antigen</a:t>
              </a:r>
            </a:p>
            <a:p>
              <a:pPr algn="ctr"/>
              <a:r>
                <a:rPr lang="en-US" dirty="0" smtClean="0">
                  <a:latin typeface="Arial" pitchFamily="34" charset="0"/>
                  <a:cs typeface="Arial" pitchFamily="34" charset="0"/>
                </a:rPr>
                <a:t>on bead</a:t>
              </a:r>
              <a:endParaRPr lang="en-US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410200" y="838200"/>
              <a:ext cx="2557110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Arial" pitchFamily="34" charset="0"/>
                  <a:cs typeface="Arial" pitchFamily="34" charset="0"/>
                </a:rPr>
                <a:t>Heavy chain of HLA</a:t>
              </a:r>
            </a:p>
            <a:p>
              <a:r>
                <a:rPr lang="en-US" dirty="0" smtClean="0">
                  <a:latin typeface="Arial" pitchFamily="34" charset="0"/>
                  <a:cs typeface="Arial" pitchFamily="34" charset="0"/>
                </a:rPr>
                <a:t>class I antigen on bead</a:t>
              </a:r>
              <a:endParaRPr lang="en-US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Rectangle 12"/>
            <p:cNvSpPr/>
            <p:nvPr/>
          </p:nvSpPr>
          <p:spPr>
            <a:xfrm>
              <a:off x="3733800" y="1752600"/>
              <a:ext cx="1752600" cy="6463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dirty="0" smtClean="0">
                  <a:latin typeface="Arial" pitchFamily="34" charset="0"/>
                  <a:cs typeface="Arial" pitchFamily="34" charset="0"/>
                </a:rPr>
                <a:t>Dissociate</a:t>
              </a:r>
            </a:p>
            <a:p>
              <a:r>
                <a:rPr lang="en-US" dirty="0" smtClean="0">
                  <a:latin typeface="Arial" pitchFamily="34" charset="0"/>
                  <a:cs typeface="Arial" pitchFamily="34" charset="0"/>
                </a:rPr>
                <a:t>with acid buffer</a:t>
              </a:r>
              <a:endParaRPr lang="en-US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981200" y="2286000"/>
              <a:ext cx="145424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Heavy chain</a:t>
              </a:r>
              <a:endParaRPr lang="en-US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057400" y="3124200"/>
              <a:ext cx="6383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β</a:t>
              </a:r>
              <a:r>
                <a:rPr lang="en-US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2m</a:t>
              </a:r>
              <a:endParaRPr lang="en-US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505200" y="3962400"/>
              <a:ext cx="6383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β</a:t>
              </a:r>
              <a:r>
                <a:rPr lang="en-US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2m</a:t>
              </a:r>
              <a:endParaRPr lang="en-US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6019800" y="2286000"/>
              <a:ext cx="145424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Heavy chain</a:t>
              </a:r>
              <a:endParaRPr lang="en-US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2057400" y="1752600"/>
              <a:ext cx="9669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Peptide</a:t>
              </a:r>
              <a:endParaRPr lang="en-US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5181600" y="3886200"/>
              <a:ext cx="9669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Arial" pitchFamily="34" charset="0"/>
                  <a:cs typeface="Arial" pitchFamily="34" charset="0"/>
                </a:rPr>
                <a:t>Peptide</a:t>
              </a:r>
              <a:endParaRPr lang="en-US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2209800" y="4953001"/>
              <a:ext cx="50292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dirty="0" smtClean="0">
                  <a:latin typeface="Arial" pitchFamily="34" charset="0"/>
                  <a:cs typeface="Arial" pitchFamily="34" charset="0"/>
                </a:rPr>
                <a:t>Β</a:t>
              </a:r>
              <a:r>
                <a:rPr lang="en-US" dirty="0" smtClean="0">
                  <a:latin typeface="Arial" pitchFamily="34" charset="0"/>
                  <a:cs typeface="Arial" pitchFamily="34" charset="0"/>
                </a:rPr>
                <a:t>2m and peptide dissociate from heavy chain</a:t>
              </a:r>
              <a:endParaRPr lang="en-US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Curved Down Arrow 26"/>
            <p:cNvSpPr/>
            <p:nvPr/>
          </p:nvSpPr>
          <p:spPr>
            <a:xfrm rot="3047058">
              <a:off x="3927843" y="2675886"/>
              <a:ext cx="990600" cy="381000"/>
            </a:xfrm>
            <a:prstGeom prst="curvedDownArrow">
              <a:avLst/>
            </a:prstGeom>
            <a:solidFill>
              <a:schemeClr val="tx1"/>
            </a:solidFill>
            <a:ln w="3175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cxnSp>
          <p:nvCxnSpPr>
            <p:cNvPr id="12" name="Straight Arrow Connector 11"/>
            <p:cNvCxnSpPr/>
            <p:nvPr/>
          </p:nvCxnSpPr>
          <p:spPr>
            <a:xfrm>
              <a:off x="3733800" y="2543251"/>
              <a:ext cx="1828800" cy="0"/>
            </a:xfrm>
            <a:prstGeom prst="straightConnector1">
              <a:avLst/>
            </a:prstGeom>
            <a:ln w="3810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1" name="Oval 30"/>
            <p:cNvSpPr/>
            <p:nvPr/>
          </p:nvSpPr>
          <p:spPr>
            <a:xfrm>
              <a:off x="3863976" y="2572468"/>
              <a:ext cx="499860" cy="201887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" name="Rounded Rectangle 31"/>
            <p:cNvSpPr/>
            <p:nvPr/>
          </p:nvSpPr>
          <p:spPr>
            <a:xfrm>
              <a:off x="3851275" y="2574925"/>
              <a:ext cx="228600" cy="45719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0" y="74711"/>
            <a:ext cx="674845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Figure A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Intact HLA class I antigens dissociated to heavy chain, β2m and peptide. </a:t>
            </a:r>
            <a:endParaRPr kumimoji="0" 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4</Words>
  <Application>Microsoft Office PowerPoint</Application>
  <PresentationFormat>On-screen Show (4:3)</PresentationFormat>
  <Paragraphs>1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adim</dc:creator>
  <cp:lastModifiedBy>Nadim</cp:lastModifiedBy>
  <cp:revision>1</cp:revision>
  <dcterms:created xsi:type="dcterms:W3CDTF">2017-03-12T03:26:40Z</dcterms:created>
  <dcterms:modified xsi:type="dcterms:W3CDTF">2017-03-12T03:28:14Z</dcterms:modified>
</cp:coreProperties>
</file>